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81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5958"/>
    <p:restoredTop sz="96029"/>
  </p:normalViewPr>
  <p:slideViewPr>
    <p:cSldViewPr snapToGrid="0" snapToObjects="1">
      <p:cViewPr varScale="1">
        <p:scale>
          <a:sx n="81" d="100"/>
          <a:sy n="81" d="100"/>
        </p:scale>
        <p:origin x="251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2B95-8075-8B42-B4B3-C72B275FDE12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F2509-F86A-B140-A04A-110B2B0E6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02920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2B95-8075-8B42-B4B3-C72B275FDE12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F2509-F86A-B140-A04A-110B2B0E6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93199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2B95-8075-8B42-B4B3-C72B275FDE12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F2509-F86A-B140-A04A-110B2B0E6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3820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2B95-8075-8B42-B4B3-C72B275FDE12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F2509-F86A-B140-A04A-110B2B0E6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68410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2B95-8075-8B42-B4B3-C72B275FDE12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F2509-F86A-B140-A04A-110B2B0E6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67387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2B95-8075-8B42-B4B3-C72B275FDE12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F2509-F86A-B140-A04A-110B2B0E6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35156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2B95-8075-8B42-B4B3-C72B275FDE12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F2509-F86A-B140-A04A-110B2B0E6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51633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2B95-8075-8B42-B4B3-C72B275FDE12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F2509-F86A-B140-A04A-110B2B0E6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70925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2B95-8075-8B42-B4B3-C72B275FDE12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F2509-F86A-B140-A04A-110B2B0E6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11175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2B95-8075-8B42-B4B3-C72B275FDE12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F2509-F86A-B140-A04A-110B2B0E6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6173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2B95-8075-8B42-B4B3-C72B275FDE12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F2509-F86A-B140-A04A-110B2B0E6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37711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0E2B95-8075-8B42-B4B3-C72B275FDE12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9F2509-F86A-B140-A04A-110B2B0E6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45499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tiff"/><Relationship Id="rId3" Type="http://schemas.openxmlformats.org/officeDocument/2006/relationships/image" Target="../media/image3.tiff"/><Relationship Id="rId7" Type="http://schemas.openxmlformats.org/officeDocument/2006/relationships/image" Target="../media/image2.w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w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94949034-BBB3-064C-A9B2-D74DE2C91BF9}"/>
              </a:ext>
            </a:extLst>
          </p:cNvPr>
          <p:cNvSpPr txBox="1"/>
          <p:nvPr/>
        </p:nvSpPr>
        <p:spPr>
          <a:xfrm>
            <a:off x="65103" y="81044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3889E45D-9CDF-3440-99CB-49B49E677BDD}"/>
              </a:ext>
            </a:extLst>
          </p:cNvPr>
          <p:cNvPicPr>
            <a:picLocks noChangeAspect="1"/>
          </p:cNvPicPr>
          <p:nvPr/>
        </p:nvPicPr>
        <p:blipFill>
          <a:blip r:embed="rId3">
            <a:grayscl/>
          </a:blip>
          <a:stretch>
            <a:fillRect/>
          </a:stretch>
        </p:blipFill>
        <p:spPr>
          <a:xfrm>
            <a:off x="319524" y="1086537"/>
            <a:ext cx="2999932" cy="2050374"/>
          </a:xfrm>
          <a:prstGeom prst="rect">
            <a:avLst/>
          </a:prstGeom>
        </p:spPr>
      </p:pic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B270DCD5-738C-3144-B5A8-F567F0BA08E1}"/>
              </a:ext>
            </a:extLst>
          </p:cNvPr>
          <p:cNvSpPr/>
          <p:nvPr/>
        </p:nvSpPr>
        <p:spPr>
          <a:xfrm>
            <a:off x="65103" y="3475672"/>
            <a:ext cx="6596061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dirty="0">
                <a:solidFill>
                  <a:srgbClr val="111111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Supplemental Figure S1</a:t>
            </a:r>
            <a:r>
              <a:rPr lang="en-US" altLang="ja-JP" dirty="0">
                <a:solidFill>
                  <a:srgbClr val="111111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: </a:t>
            </a:r>
            <a:r>
              <a:rPr lang="en-US" altLang="ja-JP" b="1" dirty="0">
                <a:solidFill>
                  <a:srgbClr val="111111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Len-R and Pom-R gained nonsense mutations of CRBN.</a:t>
            </a:r>
            <a:r>
              <a:rPr lang="en-US" altLang="ja-JP" dirty="0">
                <a:solidFill>
                  <a:srgbClr val="111111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 </a:t>
            </a:r>
            <a:endParaRPr lang="ja-JP" altLang="ja-JP"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  <a:p>
            <a:r>
              <a:rPr lang="en-US" altLang="ja-JP" dirty="0">
                <a:solidFill>
                  <a:srgbClr val="111111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A genomic screenshot around the C terminal of CRBN showed 1 unique SNP mutation (p.R418X) of both Len-R and Pom-R and 1 unique SNP mutation (p.E329X) of Pom-R.</a:t>
            </a:r>
            <a:endParaRPr lang="ja-JP" altLang="ja-JP"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0B41DB9-CC32-E541-828B-BFDB0D935488}"/>
              </a:ext>
            </a:extLst>
          </p:cNvPr>
          <p:cNvSpPr txBox="1"/>
          <p:nvPr/>
        </p:nvSpPr>
        <p:spPr>
          <a:xfrm>
            <a:off x="88518" y="5203327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2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01EA10A6-9274-4D48-B011-684BAF091C18}"/>
              </a:ext>
            </a:extLst>
          </p:cNvPr>
          <p:cNvSpPr/>
          <p:nvPr/>
        </p:nvSpPr>
        <p:spPr>
          <a:xfrm>
            <a:off x="88518" y="6933909"/>
            <a:ext cx="6596061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dirty="0">
                <a:solidFill>
                  <a:srgbClr val="111111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Supplemental Figure S2</a:t>
            </a:r>
            <a:r>
              <a:rPr lang="en-US" altLang="ja-JP" dirty="0">
                <a:solidFill>
                  <a:srgbClr val="111111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: </a:t>
            </a:r>
            <a:r>
              <a:rPr lang="en-US" altLang="ja-JP" b="1" dirty="0">
                <a:solidFill>
                  <a:srgbClr val="111111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Protein level of CRBN in Len-R and Pom-R is decreased compared with parental MM.1s.</a:t>
            </a:r>
            <a:endParaRPr lang="ja-JP" altLang="ja-JP"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  <a:p>
            <a:r>
              <a:rPr lang="en-US" altLang="ja-JP" dirty="0">
                <a:solidFill>
                  <a:srgbClr val="111111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Western blot analysis of CRBN shows protein level of CRBN is impaired in </a:t>
            </a:r>
            <a:r>
              <a:rPr lang="en-US" altLang="ja-JP" dirty="0" err="1">
                <a:solidFill>
                  <a:srgbClr val="111111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IMiD</a:t>
            </a:r>
            <a:r>
              <a:rPr lang="en-US" altLang="ja-JP" dirty="0">
                <a:solidFill>
                  <a:srgbClr val="111111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 </a:t>
            </a:r>
            <a:r>
              <a:rPr lang="en-US" altLang="ja-JP" dirty="0" err="1">
                <a:solidFill>
                  <a:srgbClr val="111111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resisntant</a:t>
            </a:r>
            <a:r>
              <a:rPr lang="en-US" altLang="ja-JP" dirty="0">
                <a:solidFill>
                  <a:srgbClr val="111111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 cell lines.</a:t>
            </a:r>
            <a:endParaRPr lang="ja-JP" altLang="ja-JP"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</p:txBody>
      </p:sp>
      <p:graphicFrame>
        <p:nvGraphicFramePr>
          <p:cNvPr id="8" name="Object 3">
            <a:extLst>
              <a:ext uri="{FF2B5EF4-FFF2-40B4-BE49-F238E27FC236}">
                <a16:creationId xmlns:a16="http://schemas.microsoft.com/office/drawing/2014/main" id="{329B5C4D-934B-764B-9EFD-7B3D51810C3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05520224"/>
              </p:ext>
            </p:extLst>
          </p:nvPr>
        </p:nvGraphicFramePr>
        <p:xfrm>
          <a:off x="2477042" y="6139385"/>
          <a:ext cx="768096" cy="1486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Image" r:id="rId4" imgW="688680" imgH="133920" progId="Photoshop.Image.13">
                  <p:embed/>
                </p:oleObj>
              </mc:Choice>
              <mc:Fallback>
                <p:oleObj name="Image" r:id="rId4" imgW="688680" imgH="133920" progId="Photoshop.Image.13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1D5B0861-27EB-4AF2-8305-47642E7D8E2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477042" y="6139385"/>
                        <a:ext cx="768096" cy="148664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4">
            <a:extLst>
              <a:ext uri="{FF2B5EF4-FFF2-40B4-BE49-F238E27FC236}">
                <a16:creationId xmlns:a16="http://schemas.microsoft.com/office/drawing/2014/main" id="{888110CA-2790-0A4A-966F-6BDAD8CA4C75}"/>
              </a:ext>
            </a:extLst>
          </p:cNvPr>
          <p:cNvSpPr txBox="1"/>
          <p:nvPr/>
        </p:nvSpPr>
        <p:spPr>
          <a:xfrm>
            <a:off x="1631105" y="6039912"/>
            <a:ext cx="8459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/>
              <a:t>Cereblon</a:t>
            </a:r>
            <a:endParaRPr lang="en-US" sz="1400" dirty="0"/>
          </a:p>
        </p:txBody>
      </p:sp>
      <p:graphicFrame>
        <p:nvGraphicFramePr>
          <p:cNvPr id="11" name="Object 21">
            <a:extLst>
              <a:ext uri="{FF2B5EF4-FFF2-40B4-BE49-F238E27FC236}">
                <a16:creationId xmlns:a16="http://schemas.microsoft.com/office/drawing/2014/main" id="{DC35CFE6-2110-9F4E-A60C-09D2D3B7785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1954827"/>
              </p:ext>
            </p:extLst>
          </p:nvPr>
        </p:nvGraphicFramePr>
        <p:xfrm>
          <a:off x="2479963" y="6407329"/>
          <a:ext cx="765175" cy="212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2" name="Image" r:id="rId6" imgW="765000" imgH="213120" progId="Photoshop.Image.13">
                  <p:embed/>
                </p:oleObj>
              </mc:Choice>
              <mc:Fallback>
                <p:oleObj name="Image" r:id="rId6" imgW="765000" imgH="213120" progId="Photoshop.Image.13">
                  <p:embed/>
                  <p:pic>
                    <p:nvPicPr>
                      <p:cNvPr id="22" name="Object 21">
                        <a:extLst>
                          <a:ext uri="{FF2B5EF4-FFF2-40B4-BE49-F238E27FC236}">
                            <a16:creationId xmlns:a16="http://schemas.microsoft.com/office/drawing/2014/main" id="{4F657990-D6B4-4673-82D2-C3E98F27F43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479963" y="6407329"/>
                        <a:ext cx="765175" cy="212725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88B8ADB-2F08-504F-8B2F-E9A48564D8ED}"/>
              </a:ext>
            </a:extLst>
          </p:cNvPr>
          <p:cNvSpPr txBox="1"/>
          <p:nvPr/>
        </p:nvSpPr>
        <p:spPr>
          <a:xfrm>
            <a:off x="1669898" y="6342024"/>
            <a:ext cx="8365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GAPDH</a:t>
            </a:r>
            <a:endParaRPr kumimoji="1" lang="ja-JP" altLang="en-US" sz="1400"/>
          </a:p>
        </p:txBody>
      </p:sp>
      <p:pic>
        <p:nvPicPr>
          <p:cNvPr id="13" name="図 12">
            <a:extLst>
              <a:ext uri="{FF2B5EF4-FFF2-40B4-BE49-F238E27FC236}">
                <a16:creationId xmlns:a16="http://schemas.microsoft.com/office/drawing/2014/main" id="{6FF03CC5-1FE3-8849-89A2-2D53DDC35290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38062" t="3321" r="4012" b="61555"/>
          <a:stretch/>
        </p:blipFill>
        <p:spPr>
          <a:xfrm>
            <a:off x="2286221" y="5572659"/>
            <a:ext cx="1204782" cy="4980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548060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578</TotalTime>
  <Words>97</Words>
  <Application>Microsoft Macintosh PowerPoint</Application>
  <PresentationFormat>A4 210 x 297 mm</PresentationFormat>
  <Paragraphs>8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Image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智章 森</dc:creator>
  <cp:lastModifiedBy>智章 森</cp:lastModifiedBy>
  <cp:revision>154</cp:revision>
  <dcterms:created xsi:type="dcterms:W3CDTF">2020-11-28T06:45:15Z</dcterms:created>
  <dcterms:modified xsi:type="dcterms:W3CDTF">2021-10-25T21:16:04Z</dcterms:modified>
</cp:coreProperties>
</file>